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  <p:sldId id="268" r:id="rId3"/>
    <p:sldId id="274" r:id="rId4"/>
    <p:sldId id="279" r:id="rId5"/>
    <p:sldId id="275" r:id="rId6"/>
    <p:sldId id="280" r:id="rId7"/>
    <p:sldId id="272" r:id="rId8"/>
    <p:sldId id="278" r:id="rId9"/>
  </p:sldIdLst>
  <p:sldSz cx="6858000" cy="9906000" type="A4"/>
  <p:notesSz cx="7102475" cy="93884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73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2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168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199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2464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258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190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913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245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802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364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56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095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5A360D-48CB-4027-A14A-51D1427EA8B3}" type="datetimeFigureOut">
              <a:rPr lang="en-US" smtClean="0"/>
              <a:t>3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E6CCD-038D-499B-8BD2-B1FD908BA5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195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2FEEF04-4A93-AFAE-EA4E-0ED6974B9F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2201122"/>
              </p:ext>
            </p:extLst>
          </p:nvPr>
        </p:nvGraphicFramePr>
        <p:xfrm>
          <a:off x="86070" y="581462"/>
          <a:ext cx="6682168" cy="2828554"/>
        </p:xfrm>
        <a:graphic>
          <a:graphicData uri="http://schemas.openxmlformats.org/drawingml/2006/table">
            <a:tbl>
              <a:tblPr/>
              <a:tblGrid>
                <a:gridCol w="548640">
                  <a:extLst>
                    <a:ext uri="{9D8B030D-6E8A-4147-A177-3AD203B41FA5}">
                      <a16:colId xmlns:a16="http://schemas.microsoft.com/office/drawing/2014/main" val="1356824653"/>
                    </a:ext>
                  </a:extLst>
                </a:gridCol>
                <a:gridCol w="1097280">
                  <a:extLst>
                    <a:ext uri="{9D8B030D-6E8A-4147-A177-3AD203B41FA5}">
                      <a16:colId xmlns:a16="http://schemas.microsoft.com/office/drawing/2014/main" val="3450208359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827560866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81753746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385346107"/>
                    </a:ext>
                  </a:extLst>
                </a:gridCol>
                <a:gridCol w="656272">
                  <a:extLst>
                    <a:ext uri="{9D8B030D-6E8A-4147-A177-3AD203B41FA5}">
                      <a16:colId xmlns:a16="http://schemas.microsoft.com/office/drawing/2014/main" val="150053412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275431961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92680487"/>
                    </a:ext>
                  </a:extLst>
                </a:gridCol>
                <a:gridCol w="539496">
                  <a:extLst>
                    <a:ext uri="{9D8B030D-6E8A-4147-A177-3AD203B41FA5}">
                      <a16:colId xmlns:a16="http://schemas.microsoft.com/office/drawing/2014/main" val="3023832232"/>
                    </a:ext>
                  </a:extLst>
                </a:gridCol>
              </a:tblGrid>
              <a:tr h="69753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marke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Stage (n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after 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ociation with Clinical Outcom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0005305"/>
                  </a:ext>
                </a:extLst>
              </a:tr>
              <a:tr h="69753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s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755846"/>
                  </a:ext>
                </a:extLst>
              </a:tr>
              <a:tr h="173306">
                <a:tc gridSpan="3"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luble Factor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4656475"/>
                  </a:ext>
                </a:extLst>
              </a:tr>
              <a:tr h="365760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oluble Facto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III - IV (n=11)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9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n-US" sz="9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D-1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↑</a:t>
                      </a:r>
                      <a:r>
                        <a:rPr lang="en-US" sz="9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p=0.027)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US" sz="9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7973024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pPr algn="ct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9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-II (</a:t>
                      </a:r>
                      <a:r>
                        <a:rPr lang="pt-BR" sz="900" kern="10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pt-BR" sz="9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=3), III-IV (</a:t>
                      </a:r>
                      <a:r>
                        <a:rPr lang="pt-BR" sz="900" kern="10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pt-BR" sz="9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=40)</a:t>
                      </a:r>
                      <a:endParaRPr lang="en-US" sz="900" kern="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n-US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D-1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US" sz="900" kern="1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↓ (p=0.008)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↓ (p=0.028)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6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9174111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pPr algn="ctr" fontAlgn="ctr"/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vanced (n=21)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n-US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D-1, </a:t>
                      </a:r>
                      <a:r>
                        <a:rPr lang="el-GR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n-US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D-L1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</a:t>
                      </a: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0202564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oluble Facto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ranzyme B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-II (n=3), III-IV (n=4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↓ (p=0.01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↓ (p=0.043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9202249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DO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I-IV (n=2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↓ (p=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1916833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RG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EMIS (n=295, 110 with NSCLC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αPD-1, αPD-L1, combination of immunotherapie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↑ (p=0.02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↑ (p=0.01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8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550529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62C7EFD-0B17-70A0-204F-3424BFEFF750}"/>
              </a:ext>
            </a:extLst>
          </p:cNvPr>
          <p:cNvSpPr txBox="1"/>
          <p:nvPr/>
        </p:nvSpPr>
        <p:spPr>
          <a:xfrm>
            <a:off x="35778" y="12032"/>
            <a:ext cx="6858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1714500" algn="l"/>
              </a:tabLst>
            </a:pPr>
            <a:r>
              <a:rPr lang="en-US" sz="1400" b="1" dirty="0">
                <a:effectLst/>
                <a:latin typeface="Calibri" panose="020F0502020204030204" pitchFamily="34" charset="0"/>
                <a:ea typeface="PMingLiU" panose="02020500000000000000" pitchFamily="18" charset="-120"/>
              </a:rPr>
              <a:t>Supplemental Table 1:  Association between soluble factors after ICI therapy and clinical outcome 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640164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BF6C4B1-5065-9723-4FB6-305AEA68D786}"/>
              </a:ext>
            </a:extLst>
          </p:cNvPr>
          <p:cNvSpPr txBox="1"/>
          <p:nvPr/>
        </p:nvSpPr>
        <p:spPr>
          <a:xfrm>
            <a:off x="0" y="0"/>
            <a:ext cx="6858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1714500" algn="l"/>
              </a:tabLst>
            </a:pPr>
            <a:r>
              <a:rPr lang="en-US" sz="1400" b="1" dirty="0">
                <a:effectLst/>
                <a:latin typeface="Calibri" panose="020F0502020204030204" pitchFamily="34" charset="0"/>
                <a:ea typeface="PMingLiU" panose="02020500000000000000" pitchFamily="18" charset="-120"/>
              </a:rPr>
              <a:t>Supplemental Table 2:  Association between soluble factors and proteomic tests at baseline and clinical outcome after ICI</a:t>
            </a:r>
            <a:endParaRPr lang="en-US" sz="1400" b="1" dirty="0"/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2590F86-1A45-B025-F155-6D47654440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8871963"/>
              </p:ext>
            </p:extLst>
          </p:nvPr>
        </p:nvGraphicFramePr>
        <p:xfrm>
          <a:off x="107009" y="482692"/>
          <a:ext cx="6643982" cy="4499291"/>
        </p:xfrm>
        <a:graphic>
          <a:graphicData uri="http://schemas.openxmlformats.org/drawingml/2006/table">
            <a:tbl>
              <a:tblPr/>
              <a:tblGrid>
                <a:gridCol w="548640">
                  <a:extLst>
                    <a:ext uri="{9D8B030D-6E8A-4147-A177-3AD203B41FA5}">
                      <a16:colId xmlns:a16="http://schemas.microsoft.com/office/drawing/2014/main" val="3049305485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3034064595"/>
                    </a:ext>
                  </a:extLst>
                </a:gridCol>
                <a:gridCol w="822960">
                  <a:extLst>
                    <a:ext uri="{9D8B030D-6E8A-4147-A177-3AD203B41FA5}">
                      <a16:colId xmlns:a16="http://schemas.microsoft.com/office/drawing/2014/main" val="1657399305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3992054409"/>
                    </a:ext>
                  </a:extLst>
                </a:gridCol>
                <a:gridCol w="608942">
                  <a:extLst>
                    <a:ext uri="{9D8B030D-6E8A-4147-A177-3AD203B41FA5}">
                      <a16:colId xmlns:a16="http://schemas.microsoft.com/office/drawing/2014/main" val="508416379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668017109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784745141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642075542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036795028"/>
                    </a:ext>
                  </a:extLst>
                </a:gridCol>
              </a:tblGrid>
              <a:tr h="128358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marke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Stage (n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at Baselin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indent="0" algn="l" rtl="0" fontAlgn="ctr">
                        <a:tabLst>
                          <a:tab pos="171450" algn="l"/>
                        </a:tabLst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	</a:t>
                      </a:r>
                      <a:r>
                        <a:rPr lang="en-US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ociation with Clinical Outcom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37787"/>
                  </a:ext>
                </a:extLst>
              </a:tr>
              <a:tr h="128358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s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8582097"/>
                  </a:ext>
                </a:extLst>
              </a:tr>
              <a:tr h="185687">
                <a:tc gridSpan="4">
                  <a:txBody>
                    <a:bodyPr/>
                    <a:lstStyle/>
                    <a:p>
                      <a:pPr algn="l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luble Factor and Proteomic Tes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6424309"/>
                  </a:ext>
                </a:extLst>
              </a:tr>
              <a:tr h="128358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oluble Facto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anzyme B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V (n=78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18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2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1097417"/>
                  </a:ext>
                </a:extLst>
              </a:tr>
              <a:tr h="2552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-II (n=3), III-IV (n=4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39)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18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96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3685125"/>
                  </a:ext>
                </a:extLst>
              </a:tr>
              <a:tr h="1283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D25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 - IV (n=6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1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0716996"/>
                  </a:ext>
                </a:extLst>
              </a:tr>
              <a:tr h="1283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DH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-IV (n=2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45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9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55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0466831"/>
                  </a:ext>
                </a:extLst>
              </a:tr>
              <a:tr h="2552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meta-analysis n=3429)</a:t>
                      </a:r>
                    </a:p>
                  </a:txBody>
                  <a:tcPr marL="1744" marR="1744" marT="1744" marB="0"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, 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LA4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23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66096077"/>
                  </a:ext>
                </a:extLst>
              </a:tr>
              <a:tr h="2552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G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P (n=77, 32 with NSCLC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4223256"/>
                  </a:ext>
                </a:extLst>
              </a:tr>
              <a:tr h="5090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MIS (n=295, 110 with NSCLC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PD-1, αPD-L1, combination of immunotherapie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07026097"/>
                  </a:ext>
                </a:extLst>
              </a:tr>
              <a:tr h="3821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pt-B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NSCLC (n=40), HNSCC (n=4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4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027868"/>
                  </a:ext>
                </a:extLst>
              </a:tr>
              <a:tr h="1283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P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106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04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001)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7423789"/>
                  </a:ext>
                </a:extLst>
              </a:tr>
              <a:tr h="382169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omic Tes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riStrat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tes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B - IV (n=28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CI monotherapy (n=11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HIC-H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1879522"/>
                  </a:ext>
                </a:extLst>
              </a:tr>
              <a:tr h="38216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CI + chemotherapy (n=16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HIC-H 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1110478"/>
                  </a:ext>
                </a:extLst>
              </a:tr>
              <a:tr h="2552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R tes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116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PIR test resistant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9941601"/>
                  </a:ext>
                </a:extLst>
              </a:tr>
              <a:tr h="2552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98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PIR test resistant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3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1437179"/>
                  </a:ext>
                </a:extLst>
              </a:tr>
              <a:tr h="25526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75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PIR test resistant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0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70452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934371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BF6C4B1-5065-9723-4FB6-305AEA68D786}"/>
              </a:ext>
            </a:extLst>
          </p:cNvPr>
          <p:cNvSpPr txBox="1"/>
          <p:nvPr/>
        </p:nvSpPr>
        <p:spPr>
          <a:xfrm>
            <a:off x="0" y="0"/>
            <a:ext cx="6858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1714500" algn="l"/>
              </a:tabLst>
            </a:pPr>
            <a:r>
              <a:rPr lang="en-US" sz="1400" b="1" dirty="0">
                <a:effectLst/>
                <a:latin typeface="Calibri" panose="020F0502020204030204" pitchFamily="34" charset="0"/>
                <a:ea typeface="PMingLiU" panose="02020500000000000000" pitchFamily="18" charset="-120"/>
              </a:rPr>
              <a:t>Supplemental Table 3:  Association between circulating lymphoid immune cells at baseline and clinical outcome after ICI</a:t>
            </a:r>
            <a:endParaRPr lang="en-US" sz="1400" b="1" dirty="0"/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2590F86-1A45-B025-F155-6D47654440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6273686"/>
              </p:ext>
            </p:extLst>
          </p:nvPr>
        </p:nvGraphicFramePr>
        <p:xfrm>
          <a:off x="107009" y="482692"/>
          <a:ext cx="6675120" cy="5080537"/>
        </p:xfrm>
        <a:graphic>
          <a:graphicData uri="http://schemas.openxmlformats.org/drawingml/2006/table">
            <a:tbl>
              <a:tblPr/>
              <a:tblGrid>
                <a:gridCol w="548640">
                  <a:extLst>
                    <a:ext uri="{9D8B030D-6E8A-4147-A177-3AD203B41FA5}">
                      <a16:colId xmlns:a16="http://schemas.microsoft.com/office/drawing/2014/main" val="3049305485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3034064595"/>
                    </a:ext>
                  </a:extLst>
                </a:gridCol>
                <a:gridCol w="822960">
                  <a:extLst>
                    <a:ext uri="{9D8B030D-6E8A-4147-A177-3AD203B41FA5}">
                      <a16:colId xmlns:a16="http://schemas.microsoft.com/office/drawing/2014/main" val="1657399305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3992054409"/>
                    </a:ext>
                  </a:extLst>
                </a:gridCol>
                <a:gridCol w="640080">
                  <a:extLst>
                    <a:ext uri="{9D8B030D-6E8A-4147-A177-3AD203B41FA5}">
                      <a16:colId xmlns:a16="http://schemas.microsoft.com/office/drawing/2014/main" val="508416379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668017109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784745141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642075542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036795028"/>
                    </a:ext>
                  </a:extLst>
                </a:gridCol>
              </a:tblGrid>
              <a:tr h="156400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marke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Stage (n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at Baselin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indent="0" algn="l" rtl="0" fontAlgn="ctr">
                        <a:tabLst>
                          <a:tab pos="171450" algn="l"/>
                        </a:tabLst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	</a:t>
                      </a:r>
                      <a:r>
                        <a:rPr lang="en-US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ociation with Clinical Outcome</a:t>
                      </a:r>
                    </a:p>
                  </a:txBody>
                  <a:tcPr marL="1744" marR="1744" marT="17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744" marR="1744" marT="17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37787"/>
                  </a:ext>
                </a:extLst>
              </a:tr>
              <a:tr h="1564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s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8582097"/>
                  </a:ext>
                </a:extLst>
              </a:tr>
              <a:tr h="212041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ulating Immune Cell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2881014"/>
                  </a:ext>
                </a:extLst>
              </a:tr>
              <a:tr h="465273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id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lymphocyte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NSCLC (n=40), HNSCC (n=4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1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0101672"/>
                  </a:ext>
                </a:extLst>
              </a:tr>
              <a:tr h="2347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cyte count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V (n=23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5126591"/>
                  </a:ext>
                </a:extLst>
              </a:tr>
              <a:tr h="46527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3 count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NSCLC (n=40), HNSCC (n=4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4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6324762"/>
                  </a:ext>
                </a:extLst>
              </a:tr>
              <a:tr h="46527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K cells count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pt-B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NSCLC (n=40), HNSCC (n=4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4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3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6806727"/>
                  </a:ext>
                </a:extLst>
              </a:tr>
              <a:tr h="46810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KG2D and CD56 MFI on T CD56 cell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ectable IIIA (n=2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/chemo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12, p=0.003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6006971"/>
                  </a:ext>
                </a:extLst>
              </a:tr>
              <a:tr h="35141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CD3-CD56+CTLA4+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ectable IIIA (n=2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/chemo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28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978227"/>
                  </a:ext>
                </a:extLst>
              </a:tr>
              <a:tr h="46810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LA4 MFI on CD3+CD56+ 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s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ectable IIIA (n=2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/chemo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1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73986"/>
                  </a:ext>
                </a:extLst>
              </a:tr>
              <a:tr h="35141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K cells/CD56dimCD16+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V - IV (n=65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6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9797136"/>
                  </a:ext>
                </a:extLst>
              </a:tr>
              <a:tr h="2347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CD19+ B cell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 - IV (n=5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2851030"/>
                  </a:ext>
                </a:extLst>
              </a:tr>
              <a:tr h="2347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IgM+ B cell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 - IV (n=5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5949536"/>
                  </a:ext>
                </a:extLst>
              </a:tr>
              <a:tr h="46527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IgM+ memory B cell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 - IV (n=50 discovery, n=70 validation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1, p&lt;0.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3, p=0.0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6580079"/>
                  </a:ext>
                </a:extLst>
              </a:tr>
              <a:tr h="35141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IgM+ memory B cell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 - IV (n=3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387507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022457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2FEEF04-4A93-AFAE-EA4E-0ED6974B9F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5503774"/>
              </p:ext>
            </p:extLst>
          </p:nvPr>
        </p:nvGraphicFramePr>
        <p:xfrm>
          <a:off x="86070" y="581462"/>
          <a:ext cx="6757416" cy="4903140"/>
        </p:xfrm>
        <a:graphic>
          <a:graphicData uri="http://schemas.openxmlformats.org/drawingml/2006/table">
            <a:tbl>
              <a:tblPr/>
              <a:tblGrid>
                <a:gridCol w="548640">
                  <a:extLst>
                    <a:ext uri="{9D8B030D-6E8A-4147-A177-3AD203B41FA5}">
                      <a16:colId xmlns:a16="http://schemas.microsoft.com/office/drawing/2014/main" val="1356824653"/>
                    </a:ext>
                  </a:extLst>
                </a:gridCol>
                <a:gridCol w="1097280">
                  <a:extLst>
                    <a:ext uri="{9D8B030D-6E8A-4147-A177-3AD203B41FA5}">
                      <a16:colId xmlns:a16="http://schemas.microsoft.com/office/drawing/2014/main" val="3450208359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827560866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81753746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385346107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50053412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275431961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92680487"/>
                    </a:ext>
                  </a:extLst>
                </a:gridCol>
                <a:gridCol w="539496">
                  <a:extLst>
                    <a:ext uri="{9D8B030D-6E8A-4147-A177-3AD203B41FA5}">
                      <a16:colId xmlns:a16="http://schemas.microsoft.com/office/drawing/2014/main" val="3023832232"/>
                    </a:ext>
                  </a:extLst>
                </a:gridCol>
              </a:tblGrid>
              <a:tr h="69753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marke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Stage (n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after 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ociation with Clinical Outcom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0005305"/>
                  </a:ext>
                </a:extLst>
              </a:tr>
              <a:tr h="69753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s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755846"/>
                  </a:ext>
                </a:extLst>
              </a:tr>
              <a:tr h="181772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ulating Immune Cell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9120346"/>
                  </a:ext>
                </a:extLst>
              </a:tr>
              <a:tr h="365760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id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mphocyte count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V (n=23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8241720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3 count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NSCLC (n=40), HNSCC (n=4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2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063518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8 count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NSCLC (n=40), HNSCC (n=4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8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2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9230775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CD8+CD45RA-CD62L-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pt-B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NSCLC (n=40), HNSCC (n=4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1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24727216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X3CR1+CD8+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 - IV (n=2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/chemo, 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/chemo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5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5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138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4963246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CD4+ T, % CD8+ T, % NK 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lls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, %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 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gd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, % MAI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V - IV (n=8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0985088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Treg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V - IV (n=8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20075673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g (CD4+CD25+CD127loFoxP3+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7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3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3088268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D-1+Treg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7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5719715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+IgM+ memory B cell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 - IV (n=50 discovery, n=70 validation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28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4177518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+IgM+ memory B cell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 - IV (n=50 discovery, n=70 validation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3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6243701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62C7EFD-0B17-70A0-204F-3424BFEFF750}"/>
              </a:ext>
            </a:extLst>
          </p:cNvPr>
          <p:cNvSpPr txBox="1"/>
          <p:nvPr/>
        </p:nvSpPr>
        <p:spPr>
          <a:xfrm>
            <a:off x="35778" y="12032"/>
            <a:ext cx="6858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1714500" algn="l"/>
              </a:tabLst>
            </a:pPr>
            <a:r>
              <a:rPr lang="en-US" sz="1400" b="1" dirty="0">
                <a:effectLst/>
                <a:latin typeface="Calibri" panose="020F0502020204030204" pitchFamily="34" charset="0"/>
                <a:ea typeface="PMingLiU" panose="02020500000000000000" pitchFamily="18" charset="-120"/>
              </a:rPr>
              <a:t>Supplemental Table 4:  Association between circulating lymphoid cells after ICI therapy and clinical outcome 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1881700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BF6C4B1-5065-9723-4FB6-305AEA68D786}"/>
              </a:ext>
            </a:extLst>
          </p:cNvPr>
          <p:cNvSpPr txBox="1"/>
          <p:nvPr/>
        </p:nvSpPr>
        <p:spPr>
          <a:xfrm>
            <a:off x="0" y="0"/>
            <a:ext cx="6858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1714500" algn="l"/>
              </a:tabLst>
            </a:pPr>
            <a:r>
              <a:rPr lang="en-US" sz="1400" b="1" dirty="0">
                <a:effectLst/>
                <a:latin typeface="Calibri" panose="020F0502020204030204" pitchFamily="34" charset="0"/>
                <a:ea typeface="PMingLiU" panose="02020500000000000000" pitchFamily="18" charset="-120"/>
              </a:rPr>
              <a:t>Supplemental Table 5:  Association between circulating myeloid immune cells at baseline and clinical outcome after ICI</a:t>
            </a:r>
            <a:endParaRPr lang="en-US" sz="1400" b="1" dirty="0"/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2590F86-1A45-B025-F155-6D47654440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44866"/>
              </p:ext>
            </p:extLst>
          </p:nvPr>
        </p:nvGraphicFramePr>
        <p:xfrm>
          <a:off x="107009" y="482692"/>
          <a:ext cx="6675120" cy="4918435"/>
        </p:xfrm>
        <a:graphic>
          <a:graphicData uri="http://schemas.openxmlformats.org/drawingml/2006/table">
            <a:tbl>
              <a:tblPr/>
              <a:tblGrid>
                <a:gridCol w="548640">
                  <a:extLst>
                    <a:ext uri="{9D8B030D-6E8A-4147-A177-3AD203B41FA5}">
                      <a16:colId xmlns:a16="http://schemas.microsoft.com/office/drawing/2014/main" val="3049305485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3034064595"/>
                    </a:ext>
                  </a:extLst>
                </a:gridCol>
                <a:gridCol w="822960">
                  <a:extLst>
                    <a:ext uri="{9D8B030D-6E8A-4147-A177-3AD203B41FA5}">
                      <a16:colId xmlns:a16="http://schemas.microsoft.com/office/drawing/2014/main" val="1657399305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3992054409"/>
                    </a:ext>
                  </a:extLst>
                </a:gridCol>
                <a:gridCol w="640080">
                  <a:extLst>
                    <a:ext uri="{9D8B030D-6E8A-4147-A177-3AD203B41FA5}">
                      <a16:colId xmlns:a16="http://schemas.microsoft.com/office/drawing/2014/main" val="508416379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668017109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784745141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642075542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036795028"/>
                    </a:ext>
                  </a:extLst>
                </a:gridCol>
              </a:tblGrid>
              <a:tr h="156400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marke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Stage (n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at Baselin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indent="0" algn="l" rtl="0" fontAlgn="ctr">
                        <a:tabLst>
                          <a:tab pos="171450" algn="l"/>
                        </a:tabLst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	</a:t>
                      </a:r>
                      <a:r>
                        <a:rPr lang="en-US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ociation with Clinical Outcom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37787"/>
                  </a:ext>
                </a:extLst>
              </a:tr>
              <a:tr h="1564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s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8582097"/>
                  </a:ext>
                </a:extLst>
              </a:tr>
              <a:tr h="203575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ulating Immune Cell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2881014"/>
                  </a:ext>
                </a:extLst>
              </a:tr>
              <a:tr h="351412">
                <a:tc rowSpan="10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eloid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L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24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1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77151522"/>
                  </a:ext>
                </a:extLst>
              </a:tr>
              <a:tr h="46527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2106 from 17 studies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07131165"/>
                  </a:ext>
                </a:extLst>
              </a:tr>
              <a:tr h="46527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11b+CD116+CD66b+CD3-CD14- (low-density neutrophils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A - IV (n=3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0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71071788"/>
                  </a:ext>
                </a:extLst>
              </a:tr>
              <a:tr h="46527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osinophil count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or metastatic (n=166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mediat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83942581"/>
                  </a:ext>
                </a:extLst>
              </a:tr>
              <a:tr h="35141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osinophil count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B - IV (n=158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25149242"/>
                  </a:ext>
                </a:extLst>
              </a:tr>
              <a:tr h="7741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-MDSC, eosinophils counts, NLR, neutrophils counts (immuno-asset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B - IV (n=53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ood immune asset (↑,↑,↓,↓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15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5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02888949"/>
                  </a:ext>
                </a:extLst>
              </a:tr>
              <a:tr h="35141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-MDSC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B - IV (n=53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3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37776525"/>
                  </a:ext>
                </a:extLst>
              </a:tr>
              <a:tr h="35141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+ neutrophil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11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/chemo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/chemo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90543379"/>
                  </a:ext>
                </a:extLst>
              </a:tr>
              <a:tr h="35141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+ platele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11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/chemo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/chemo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21063534"/>
                  </a:ext>
                </a:extLst>
              </a:tr>
              <a:tr h="35141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+ platele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n=2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3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04590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957842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2FEEF04-4A93-AFAE-EA4E-0ED6974B9F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3231465"/>
              </p:ext>
            </p:extLst>
          </p:nvPr>
        </p:nvGraphicFramePr>
        <p:xfrm>
          <a:off x="86070" y="581462"/>
          <a:ext cx="6757416" cy="2871295"/>
        </p:xfrm>
        <a:graphic>
          <a:graphicData uri="http://schemas.openxmlformats.org/drawingml/2006/table">
            <a:tbl>
              <a:tblPr/>
              <a:tblGrid>
                <a:gridCol w="548640">
                  <a:extLst>
                    <a:ext uri="{9D8B030D-6E8A-4147-A177-3AD203B41FA5}">
                      <a16:colId xmlns:a16="http://schemas.microsoft.com/office/drawing/2014/main" val="1356824653"/>
                    </a:ext>
                  </a:extLst>
                </a:gridCol>
                <a:gridCol w="1097280">
                  <a:extLst>
                    <a:ext uri="{9D8B030D-6E8A-4147-A177-3AD203B41FA5}">
                      <a16:colId xmlns:a16="http://schemas.microsoft.com/office/drawing/2014/main" val="3450208359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827560866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81753746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385346107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50053412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275431961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92680487"/>
                    </a:ext>
                  </a:extLst>
                </a:gridCol>
                <a:gridCol w="539496">
                  <a:extLst>
                    <a:ext uri="{9D8B030D-6E8A-4147-A177-3AD203B41FA5}">
                      <a16:colId xmlns:a16="http://schemas.microsoft.com/office/drawing/2014/main" val="3023832232"/>
                    </a:ext>
                  </a:extLst>
                </a:gridCol>
              </a:tblGrid>
              <a:tr h="69753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marke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Stage (n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after 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ociation with Clinical Outcome</a:t>
                      </a:r>
                    </a:p>
                  </a:txBody>
                  <a:tcPr marL="1744" marR="1744" marT="17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744" marR="1744" marT="17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0005305"/>
                  </a:ext>
                </a:extLst>
              </a:tr>
              <a:tr h="69753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s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755846"/>
                  </a:ext>
                </a:extLst>
              </a:tr>
              <a:tr h="216047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ulating Immune Cell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9120346"/>
                  </a:ext>
                </a:extLst>
              </a:tr>
              <a:tr h="365760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eloid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L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24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4655693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(n=2106 from 17 studies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4463537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 - IIIA resectable (n=26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LA4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2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09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70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610243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-classical CD14dimCD16+ monocyte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B - IV (n=65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3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3122764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osinophils CD15+CD16-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B - IV (n=65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3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8250298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eosinophil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 - IIIA resectable (n=26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LA4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5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446387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62C7EFD-0B17-70A0-204F-3424BFEFF750}"/>
              </a:ext>
            </a:extLst>
          </p:cNvPr>
          <p:cNvSpPr txBox="1"/>
          <p:nvPr/>
        </p:nvSpPr>
        <p:spPr>
          <a:xfrm>
            <a:off x="35778" y="12032"/>
            <a:ext cx="6858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1714500" algn="l"/>
              </a:tabLst>
            </a:pPr>
            <a:r>
              <a:rPr lang="en-US" sz="1400" b="1" dirty="0">
                <a:effectLst/>
                <a:latin typeface="Calibri" panose="020F0502020204030204" pitchFamily="34" charset="0"/>
                <a:ea typeface="PMingLiU" panose="02020500000000000000" pitchFamily="18" charset="-120"/>
              </a:rPr>
              <a:t>Supplemental Table 6:  Association between circulating myeloid cells after ICI therapy and clinical outcome 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3003029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CBD4995-581E-7F4F-605A-4CA8512C9912}"/>
              </a:ext>
            </a:extLst>
          </p:cNvPr>
          <p:cNvSpPr txBox="1"/>
          <p:nvPr/>
        </p:nvSpPr>
        <p:spPr>
          <a:xfrm>
            <a:off x="134471" y="160288"/>
            <a:ext cx="672352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1714500" algn="l"/>
              </a:tabLst>
            </a:pPr>
            <a:r>
              <a:rPr lang="en-US" sz="1400" b="1" dirty="0">
                <a:effectLst/>
                <a:latin typeface="Calibri" panose="020F0502020204030204" pitchFamily="34" charset="0"/>
                <a:ea typeface="PMingLiU" panose="02020500000000000000" pitchFamily="18" charset="-120"/>
              </a:rPr>
              <a:t>Supplemental Table 7:  Association between circulating DNA, blood tumor mutation burden, and circulating tumor cells at baseline and clinical outcome after ICI</a:t>
            </a:r>
            <a:endParaRPr lang="en-US" sz="1400" b="1" dirty="0"/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8B23FE46-E147-61AE-B430-86FB127B36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2632748"/>
              </p:ext>
            </p:extLst>
          </p:nvPr>
        </p:nvGraphicFramePr>
        <p:xfrm>
          <a:off x="136255" y="835898"/>
          <a:ext cx="6585490" cy="3449979"/>
        </p:xfrm>
        <a:graphic>
          <a:graphicData uri="http://schemas.openxmlformats.org/drawingml/2006/table">
            <a:tbl>
              <a:tblPr/>
              <a:tblGrid>
                <a:gridCol w="457200">
                  <a:extLst>
                    <a:ext uri="{9D8B030D-6E8A-4147-A177-3AD203B41FA5}">
                      <a16:colId xmlns:a16="http://schemas.microsoft.com/office/drawing/2014/main" val="595558765"/>
                    </a:ext>
                  </a:extLst>
                </a:gridCol>
                <a:gridCol w="1097280">
                  <a:extLst>
                    <a:ext uri="{9D8B030D-6E8A-4147-A177-3AD203B41FA5}">
                      <a16:colId xmlns:a16="http://schemas.microsoft.com/office/drawing/2014/main" val="1367703633"/>
                    </a:ext>
                  </a:extLst>
                </a:gridCol>
                <a:gridCol w="824770">
                  <a:extLst>
                    <a:ext uri="{9D8B030D-6E8A-4147-A177-3AD203B41FA5}">
                      <a16:colId xmlns:a16="http://schemas.microsoft.com/office/drawing/2014/main" val="2586436127"/>
                    </a:ext>
                  </a:extLst>
                </a:gridCol>
                <a:gridCol w="822960">
                  <a:extLst>
                    <a:ext uri="{9D8B030D-6E8A-4147-A177-3AD203B41FA5}">
                      <a16:colId xmlns:a16="http://schemas.microsoft.com/office/drawing/2014/main" val="1677712849"/>
                    </a:ext>
                  </a:extLst>
                </a:gridCol>
                <a:gridCol w="640080">
                  <a:extLst>
                    <a:ext uri="{9D8B030D-6E8A-4147-A177-3AD203B41FA5}">
                      <a16:colId xmlns:a16="http://schemas.microsoft.com/office/drawing/2014/main" val="1444553220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006628711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27787546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42699791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1413792181"/>
                    </a:ext>
                  </a:extLst>
                </a:gridCol>
              </a:tblGrid>
              <a:tr h="69753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marke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Stage (n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at Baselin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l" rtl="0" fontAlgn="ctr">
                        <a:tabLst>
                          <a:tab pos="171450" algn="l"/>
                        </a:tabLst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	</a:t>
                      </a:r>
                      <a:r>
                        <a:rPr lang="en-US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ociation with Clinical Outcom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473519"/>
                  </a:ext>
                </a:extLst>
              </a:tr>
              <a:tr h="69753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s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2163464"/>
                  </a:ext>
                </a:extLst>
              </a:tr>
              <a:tr h="198627">
                <a:tc gridSpan="9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ulating DNA, Blood Tumor Mutation Burden, and Circulating Tumor Cell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7360135"/>
                  </a:ext>
                </a:extLst>
              </a:tr>
              <a:tr h="3657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fDNA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fDNA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n=8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0570169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fDNA, CTC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n=8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,↓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7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62955093"/>
                  </a:ext>
                </a:extLst>
              </a:tr>
              <a:tr h="3657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TMB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TMB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B - IV (n= 211 from POPLAR, 583 from OAK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55, p=0.036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0122384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B - IVB (n=15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&lt;0.0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32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9316191"/>
                  </a:ext>
                </a:extLst>
              </a:tr>
              <a:tr h="36576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C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C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n=89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5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4225413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B - IV (n=10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3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6259438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 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n=96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&lt;0.0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00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088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4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6161869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+ CTC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vanced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n=96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(p=0.0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36106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568090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2FEEF04-4A93-AFAE-EA4E-0ED6974B9F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3085222"/>
              </p:ext>
            </p:extLst>
          </p:nvPr>
        </p:nvGraphicFramePr>
        <p:xfrm>
          <a:off x="86070" y="581462"/>
          <a:ext cx="6757416" cy="1343858"/>
        </p:xfrm>
        <a:graphic>
          <a:graphicData uri="http://schemas.openxmlformats.org/drawingml/2006/table">
            <a:tbl>
              <a:tblPr/>
              <a:tblGrid>
                <a:gridCol w="548640">
                  <a:extLst>
                    <a:ext uri="{9D8B030D-6E8A-4147-A177-3AD203B41FA5}">
                      <a16:colId xmlns:a16="http://schemas.microsoft.com/office/drawing/2014/main" val="1356824653"/>
                    </a:ext>
                  </a:extLst>
                </a:gridCol>
                <a:gridCol w="1097280">
                  <a:extLst>
                    <a:ext uri="{9D8B030D-6E8A-4147-A177-3AD203B41FA5}">
                      <a16:colId xmlns:a16="http://schemas.microsoft.com/office/drawing/2014/main" val="3450208359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827560866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817537460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3385346107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500534122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275431961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92680487"/>
                    </a:ext>
                  </a:extLst>
                </a:gridCol>
                <a:gridCol w="539496">
                  <a:extLst>
                    <a:ext uri="{9D8B030D-6E8A-4147-A177-3AD203B41FA5}">
                      <a16:colId xmlns:a16="http://schemas.microsoft.com/office/drawing/2014/main" val="3023832232"/>
                    </a:ext>
                  </a:extLst>
                </a:gridCol>
              </a:tblGrid>
              <a:tr h="69753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marker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SCLC Stage (n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ion after treatment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sng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ociation with Clinical Outcom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0005305"/>
                  </a:ext>
                </a:extLst>
              </a:tr>
              <a:tr h="69753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se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755846"/>
                  </a:ext>
                </a:extLst>
              </a:tr>
              <a:tr h="199114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ulating DNA, Blood Tumor Mutation Burden, and Circulating Tumor Cells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6045442"/>
                  </a:ext>
                </a:extLst>
              </a:tr>
              <a:tr h="3657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C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C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B - IV (n=10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4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3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4408644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+ CTC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B - IV (n=1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1, </a:t>
                      </a: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↓ 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↑ (p=0.001)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5</a:t>
                      </a:r>
                    </a:p>
                  </a:txBody>
                  <a:tcPr marL="1744" marR="1744" marT="1744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992907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6BE3948-5CCA-C38E-3536-26FBD3102D84}"/>
              </a:ext>
            </a:extLst>
          </p:cNvPr>
          <p:cNvSpPr txBox="1"/>
          <p:nvPr/>
        </p:nvSpPr>
        <p:spPr>
          <a:xfrm>
            <a:off x="287902" y="58242"/>
            <a:ext cx="628219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1714500" algn="l"/>
              </a:tabLst>
            </a:pPr>
            <a:r>
              <a:rPr lang="en-US" sz="1400" b="1" dirty="0">
                <a:effectLst/>
                <a:latin typeface="Calibri" panose="020F0502020204030204" pitchFamily="34" charset="0"/>
                <a:ea typeface="PMingLiU" panose="02020500000000000000" pitchFamily="18" charset="-120"/>
              </a:rPr>
              <a:t>Supplemental Table </a:t>
            </a:r>
            <a:r>
              <a:rPr lang="en-US" sz="1400" b="1" dirty="0">
                <a:latin typeface="Calibri" panose="020F0502020204030204" pitchFamily="34" charset="0"/>
                <a:ea typeface="PMingLiU" panose="02020500000000000000" pitchFamily="18" charset="-120"/>
              </a:rPr>
              <a:t>8</a:t>
            </a:r>
            <a:r>
              <a:rPr lang="en-US" sz="1400" b="1" dirty="0">
                <a:effectLst/>
                <a:latin typeface="Calibri" panose="020F0502020204030204" pitchFamily="34" charset="0"/>
                <a:ea typeface="PMingLiU" panose="02020500000000000000" pitchFamily="18" charset="-120"/>
              </a:rPr>
              <a:t>:  Association between CTCs after ICI therapy and clinical outcome 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295563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27</TotalTime>
  <Words>2268</Words>
  <Application>Microsoft Office PowerPoint</Application>
  <PresentationFormat>A4 Paper (210x297 mm)</PresentationFormat>
  <Paragraphs>58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nahue, Renee (NIH/NCI) [E]</dc:creator>
  <cp:lastModifiedBy>Donahue, Renee (NIH/NCI) [E]</cp:lastModifiedBy>
  <cp:revision>24</cp:revision>
  <cp:lastPrinted>2024-03-12T14:52:25Z</cp:lastPrinted>
  <dcterms:created xsi:type="dcterms:W3CDTF">2023-11-16T20:29:38Z</dcterms:created>
  <dcterms:modified xsi:type="dcterms:W3CDTF">2024-03-12T14:56:32Z</dcterms:modified>
</cp:coreProperties>
</file>